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0" r:id="rId2"/>
    <p:sldId id="261" r:id="rId3"/>
    <p:sldId id="256" r:id="rId4"/>
    <p:sldId id="258" r:id="rId5"/>
    <p:sldId id="268" r:id="rId6"/>
    <p:sldId id="267" r:id="rId7"/>
    <p:sldId id="262" r:id="rId8"/>
    <p:sldId id="266" r:id="rId9"/>
    <p:sldId id="265" r:id="rId10"/>
    <p:sldId id="269" r:id="rId11"/>
    <p:sldId id="257" r:id="rId12"/>
    <p:sldId id="259" r:id="rId13"/>
    <p:sldId id="270" r:id="rId14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>
      <p:cViewPr>
        <p:scale>
          <a:sx n="83" d="100"/>
          <a:sy n="83" d="100"/>
        </p:scale>
        <p:origin x="3024" y="10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3577-34AD-4D41-98B2-EB0564399755}" type="datetimeFigureOut">
              <a:rPr kumimoji="1" lang="zh-CN" altLang="en-US" smtClean="0"/>
              <a:t>2023/5/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EB40E-6F3F-BE44-A139-21638EB0D0A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628159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3577-34AD-4D41-98B2-EB0564399755}" type="datetimeFigureOut">
              <a:rPr kumimoji="1" lang="zh-CN" altLang="en-US" smtClean="0"/>
              <a:t>2023/5/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EB40E-6F3F-BE44-A139-21638EB0D0A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8527648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3577-34AD-4D41-98B2-EB0564399755}" type="datetimeFigureOut">
              <a:rPr kumimoji="1" lang="zh-CN" altLang="en-US" smtClean="0"/>
              <a:t>2023/5/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EB40E-6F3F-BE44-A139-21638EB0D0A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289496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3577-34AD-4D41-98B2-EB0564399755}" type="datetimeFigureOut">
              <a:rPr kumimoji="1" lang="zh-CN" altLang="en-US" smtClean="0"/>
              <a:t>2023/5/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EB40E-6F3F-BE44-A139-21638EB0D0A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536920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3577-34AD-4D41-98B2-EB0564399755}" type="datetimeFigureOut">
              <a:rPr kumimoji="1" lang="zh-CN" altLang="en-US" smtClean="0"/>
              <a:t>2023/5/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EB40E-6F3F-BE44-A139-21638EB0D0A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8709015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3577-34AD-4D41-98B2-EB0564399755}" type="datetimeFigureOut">
              <a:rPr kumimoji="1" lang="zh-CN" altLang="en-US" smtClean="0"/>
              <a:t>2023/5/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EB40E-6F3F-BE44-A139-21638EB0D0A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322631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3577-34AD-4D41-98B2-EB0564399755}" type="datetimeFigureOut">
              <a:rPr kumimoji="1" lang="zh-CN" altLang="en-US" smtClean="0"/>
              <a:t>2023/5/7</a:t>
            </a:fld>
            <a:endParaRPr kumimoji="1"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EB40E-6F3F-BE44-A139-21638EB0D0A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0878238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3577-34AD-4D41-98B2-EB0564399755}" type="datetimeFigureOut">
              <a:rPr kumimoji="1" lang="zh-CN" altLang="en-US" smtClean="0"/>
              <a:t>2023/5/7</a:t>
            </a:fld>
            <a:endParaRPr kumimoji="1"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EB40E-6F3F-BE44-A139-21638EB0D0A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618676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3577-34AD-4D41-98B2-EB0564399755}" type="datetimeFigureOut">
              <a:rPr kumimoji="1" lang="zh-CN" altLang="en-US" smtClean="0"/>
              <a:t>2023/5/7</a:t>
            </a:fld>
            <a:endParaRPr kumimoji="1"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EB40E-6F3F-BE44-A139-21638EB0D0A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4610160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3577-34AD-4D41-98B2-EB0564399755}" type="datetimeFigureOut">
              <a:rPr kumimoji="1" lang="zh-CN" altLang="en-US" smtClean="0"/>
              <a:t>2023/5/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EB40E-6F3F-BE44-A139-21638EB0D0A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59135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B783577-34AD-4D41-98B2-EB0564399755}" type="datetimeFigureOut">
              <a:rPr kumimoji="1" lang="zh-CN" altLang="en-US" smtClean="0"/>
              <a:t>2023/5/7</a:t>
            </a:fld>
            <a:endParaRPr kumimoji="1"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EB40E-6F3F-BE44-A139-21638EB0D0A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5426596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B783577-34AD-4D41-98B2-EB0564399755}" type="datetimeFigureOut">
              <a:rPr kumimoji="1" lang="zh-CN" altLang="en-US" smtClean="0"/>
              <a:t>2023/5/7</a:t>
            </a:fld>
            <a:endParaRPr kumimoji="1"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6EB40E-6F3F-BE44-A139-21638EB0D0AD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7435110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Ti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电子设备&#10;&#10;低可信度描述已自动生成">
            <a:extLst>
              <a:ext uri="{FF2B5EF4-FFF2-40B4-BE49-F238E27FC236}">
                <a16:creationId xmlns:a16="http://schemas.microsoft.com/office/drawing/2014/main" id="{5C7A91F3-F6FD-D435-65C6-B7E763D6751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689" y="41564"/>
            <a:ext cx="8520545" cy="6816436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B6FB867C-3BB7-24B6-155D-4D703ACBF260}"/>
              </a:ext>
            </a:extLst>
          </p:cNvPr>
          <p:cNvSpPr txBox="1"/>
          <p:nvPr/>
        </p:nvSpPr>
        <p:spPr>
          <a:xfrm>
            <a:off x="258816" y="231227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6A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5B59A73-9BEB-AC10-E883-A358D1E7C5C9}"/>
              </a:ext>
            </a:extLst>
          </p:cNvPr>
          <p:cNvSpPr txBox="1"/>
          <p:nvPr/>
        </p:nvSpPr>
        <p:spPr>
          <a:xfrm>
            <a:off x="5834675" y="2560904"/>
            <a:ext cx="931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P-NF-kB</a:t>
            </a:r>
          </a:p>
        </p:txBody>
      </p:sp>
    </p:spTree>
    <p:extLst>
      <p:ext uri="{BB962C8B-B14F-4D97-AF65-F5344CB8AC3E}">
        <p14:creationId xmlns:p14="http://schemas.microsoft.com/office/powerpoint/2010/main" val="364373517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8B0D1869-9BE8-D0FB-F031-973A4634250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8483" y="390778"/>
            <a:ext cx="7772400" cy="6235995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B6FB867C-3BB7-24B6-155D-4D703ACBF260}"/>
              </a:ext>
            </a:extLst>
          </p:cNvPr>
          <p:cNvSpPr txBox="1"/>
          <p:nvPr/>
        </p:nvSpPr>
        <p:spPr>
          <a:xfrm>
            <a:off x="258816" y="231227"/>
            <a:ext cx="1079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6D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5B59A73-9BEB-AC10-E883-A358D1E7C5C9}"/>
              </a:ext>
            </a:extLst>
          </p:cNvPr>
          <p:cNvSpPr txBox="1"/>
          <p:nvPr/>
        </p:nvSpPr>
        <p:spPr>
          <a:xfrm>
            <a:off x="5285270" y="2441745"/>
            <a:ext cx="814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MP1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03872086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片包含 吉他, 猫, 游戏机, 房间&#10;&#10;描述已自动生成">
            <a:extLst>
              <a:ext uri="{FF2B5EF4-FFF2-40B4-BE49-F238E27FC236}">
                <a16:creationId xmlns:a16="http://schemas.microsoft.com/office/drawing/2014/main" id="{F805D591-11FD-55FF-19D9-40C851140F3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82642" y="155028"/>
            <a:ext cx="8378715" cy="6702972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B6FB867C-3BB7-24B6-155D-4D703ACBF260}"/>
              </a:ext>
            </a:extLst>
          </p:cNvPr>
          <p:cNvSpPr txBox="1"/>
          <p:nvPr/>
        </p:nvSpPr>
        <p:spPr>
          <a:xfrm>
            <a:off x="258816" y="231227"/>
            <a:ext cx="1079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6D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5B59A73-9BEB-AC10-E883-A358D1E7C5C9}"/>
              </a:ext>
            </a:extLst>
          </p:cNvPr>
          <p:cNvSpPr txBox="1"/>
          <p:nvPr/>
        </p:nvSpPr>
        <p:spPr>
          <a:xfrm>
            <a:off x="5770180" y="2732690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B-actin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23688717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098CDA87-F988-A67C-496D-4AF530BAB3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800" y="311002"/>
            <a:ext cx="7772400" cy="6235995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B6FB867C-3BB7-24B6-155D-4D703ACBF260}"/>
              </a:ext>
            </a:extLst>
          </p:cNvPr>
          <p:cNvSpPr txBox="1"/>
          <p:nvPr/>
        </p:nvSpPr>
        <p:spPr>
          <a:xfrm>
            <a:off x="258816" y="231227"/>
            <a:ext cx="1079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6D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5B59A73-9BEB-AC10-E883-A358D1E7C5C9}"/>
              </a:ext>
            </a:extLst>
          </p:cNvPr>
          <p:cNvSpPr txBox="1"/>
          <p:nvPr/>
        </p:nvSpPr>
        <p:spPr>
          <a:xfrm>
            <a:off x="5534653" y="3059667"/>
            <a:ext cx="814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MMP1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65203523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 descr="手机屏幕的截图&#10;&#10;低可信度描述已自动生成">
            <a:extLst>
              <a:ext uri="{FF2B5EF4-FFF2-40B4-BE49-F238E27FC236}">
                <a16:creationId xmlns:a16="http://schemas.microsoft.com/office/drawing/2014/main" id="{CC922C1C-8D65-E8CD-3653-A49AC6D7534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8816" y="86031"/>
            <a:ext cx="8174182" cy="6539346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B6FB867C-3BB7-24B6-155D-4D703ACBF260}"/>
              </a:ext>
            </a:extLst>
          </p:cNvPr>
          <p:cNvSpPr txBox="1"/>
          <p:nvPr/>
        </p:nvSpPr>
        <p:spPr>
          <a:xfrm>
            <a:off x="258816" y="231227"/>
            <a:ext cx="1079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6D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5B59A73-9BEB-AC10-E883-A358D1E7C5C9}"/>
              </a:ext>
            </a:extLst>
          </p:cNvPr>
          <p:cNvSpPr txBox="1"/>
          <p:nvPr/>
        </p:nvSpPr>
        <p:spPr>
          <a:xfrm>
            <a:off x="5784035" y="2986372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B-actin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6190563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片包含 散点图&#10;&#10;描述已自动生成">
            <a:extLst>
              <a:ext uri="{FF2B5EF4-FFF2-40B4-BE49-F238E27FC236}">
                <a16:creationId xmlns:a16="http://schemas.microsoft.com/office/drawing/2014/main" id="{64668506-553C-F533-C638-4CA91D6907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8816" y="124690"/>
            <a:ext cx="8416636" cy="6733309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B6FB867C-3BB7-24B6-155D-4D703ACBF260}"/>
              </a:ext>
            </a:extLst>
          </p:cNvPr>
          <p:cNvSpPr txBox="1"/>
          <p:nvPr/>
        </p:nvSpPr>
        <p:spPr>
          <a:xfrm>
            <a:off x="258816" y="231227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6A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5B59A73-9BEB-AC10-E883-A358D1E7C5C9}"/>
              </a:ext>
            </a:extLst>
          </p:cNvPr>
          <p:cNvSpPr txBox="1"/>
          <p:nvPr/>
        </p:nvSpPr>
        <p:spPr>
          <a:xfrm>
            <a:off x="5460603" y="3059668"/>
            <a:ext cx="7393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NF-kB</a:t>
            </a:r>
          </a:p>
        </p:txBody>
      </p:sp>
    </p:spTree>
    <p:extLst>
      <p:ext uri="{BB962C8B-B14F-4D97-AF65-F5344CB8AC3E}">
        <p14:creationId xmlns:p14="http://schemas.microsoft.com/office/powerpoint/2010/main" val="13864596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 descr="图片包含 游戏机, 房间&#10;&#10;描述已自动生成">
            <a:extLst>
              <a:ext uri="{FF2B5EF4-FFF2-40B4-BE49-F238E27FC236}">
                <a16:creationId xmlns:a16="http://schemas.microsoft.com/office/drawing/2014/main" id="{95579947-13EC-8927-C89B-3A9AFA0704F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6775" y="76200"/>
            <a:ext cx="8391197" cy="6712957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B6FB867C-3BB7-24B6-155D-4D703ACBF260}"/>
              </a:ext>
            </a:extLst>
          </p:cNvPr>
          <p:cNvSpPr txBox="1"/>
          <p:nvPr/>
        </p:nvSpPr>
        <p:spPr>
          <a:xfrm>
            <a:off x="258816" y="231227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6A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5B59A73-9BEB-AC10-E883-A358D1E7C5C9}"/>
              </a:ext>
            </a:extLst>
          </p:cNvPr>
          <p:cNvSpPr txBox="1"/>
          <p:nvPr/>
        </p:nvSpPr>
        <p:spPr>
          <a:xfrm>
            <a:off x="5349766" y="2690648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B-actin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4823833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6517A01-4C5C-CDBD-9736-3D2CDF3FC6A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61721">
            <a:off x="522837" y="415893"/>
            <a:ext cx="7772400" cy="6235995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B6FB867C-3BB7-24B6-155D-4D703ACBF260}"/>
              </a:ext>
            </a:extLst>
          </p:cNvPr>
          <p:cNvSpPr txBox="1"/>
          <p:nvPr/>
        </p:nvSpPr>
        <p:spPr>
          <a:xfrm>
            <a:off x="258816" y="231227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6A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5B59A73-9BEB-AC10-E883-A358D1E7C5C9}"/>
              </a:ext>
            </a:extLst>
          </p:cNvPr>
          <p:cNvSpPr txBox="1"/>
          <p:nvPr/>
        </p:nvSpPr>
        <p:spPr>
          <a:xfrm>
            <a:off x="5360276" y="3059668"/>
            <a:ext cx="9215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P-NF-kB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7953516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B80B9F8C-1AED-882C-11C3-1303A4D8DDA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2405" y="311002"/>
            <a:ext cx="7772400" cy="6235995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B6FB867C-3BB7-24B6-155D-4D703ACBF260}"/>
              </a:ext>
            </a:extLst>
          </p:cNvPr>
          <p:cNvSpPr txBox="1"/>
          <p:nvPr/>
        </p:nvSpPr>
        <p:spPr>
          <a:xfrm>
            <a:off x="258816" y="231227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6A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5B59A73-9BEB-AC10-E883-A358D1E7C5C9}"/>
              </a:ext>
            </a:extLst>
          </p:cNvPr>
          <p:cNvSpPr txBox="1"/>
          <p:nvPr/>
        </p:nvSpPr>
        <p:spPr>
          <a:xfrm>
            <a:off x="4862336" y="3059667"/>
            <a:ext cx="7393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NF-kB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482121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 descr="图片包含 游戏机, 房间&#10;&#10;描述已自动生成">
            <a:extLst>
              <a:ext uri="{FF2B5EF4-FFF2-40B4-BE49-F238E27FC236}">
                <a16:creationId xmlns:a16="http://schemas.microsoft.com/office/drawing/2014/main" id="{DA273CDE-5F04-5EDB-08D9-399F463744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8816" y="76199"/>
            <a:ext cx="8326164" cy="6660931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B6FB867C-3BB7-24B6-155D-4D703ACBF260}"/>
              </a:ext>
            </a:extLst>
          </p:cNvPr>
          <p:cNvSpPr txBox="1"/>
          <p:nvPr/>
        </p:nvSpPr>
        <p:spPr>
          <a:xfrm>
            <a:off x="258816" y="231227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6A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5B59A73-9BEB-AC10-E883-A358D1E7C5C9}"/>
              </a:ext>
            </a:extLst>
          </p:cNvPr>
          <p:cNvSpPr txBox="1"/>
          <p:nvPr/>
        </p:nvSpPr>
        <p:spPr>
          <a:xfrm>
            <a:off x="5360276" y="3059668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B-actin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542452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>
            <a:extLst>
              <a:ext uri="{FF2B5EF4-FFF2-40B4-BE49-F238E27FC236}">
                <a16:creationId xmlns:a16="http://schemas.microsoft.com/office/drawing/2014/main" id="{42D862BD-E877-FA16-B5EC-C524150BE9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800" y="443602"/>
            <a:ext cx="7772400" cy="6235995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B6FB867C-3BB7-24B6-155D-4D703ACBF260}"/>
              </a:ext>
            </a:extLst>
          </p:cNvPr>
          <p:cNvSpPr txBox="1"/>
          <p:nvPr/>
        </p:nvSpPr>
        <p:spPr>
          <a:xfrm>
            <a:off x="258816" y="231227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6A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5B59A73-9BEB-AC10-E883-A358D1E7C5C9}"/>
              </a:ext>
            </a:extLst>
          </p:cNvPr>
          <p:cNvSpPr txBox="1"/>
          <p:nvPr/>
        </p:nvSpPr>
        <p:spPr>
          <a:xfrm>
            <a:off x="4061906" y="2619697"/>
            <a:ext cx="931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P-NF-kB</a:t>
            </a:r>
            <a:endParaRPr kumimoji="1" lang="zh-CN" altLang="en-US" dirty="0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71C50937-93D5-932C-3C53-CC04A88504CE}"/>
              </a:ext>
            </a:extLst>
          </p:cNvPr>
          <p:cNvSpPr/>
          <p:nvPr/>
        </p:nvSpPr>
        <p:spPr>
          <a:xfrm>
            <a:off x="2613892" y="2989029"/>
            <a:ext cx="1486863" cy="36377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5148604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E474D2C1-60CB-496E-654D-094F73E76D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5800" y="311002"/>
            <a:ext cx="7772400" cy="6235995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B6FB867C-3BB7-24B6-155D-4D703ACBF260}"/>
              </a:ext>
            </a:extLst>
          </p:cNvPr>
          <p:cNvSpPr txBox="1"/>
          <p:nvPr/>
        </p:nvSpPr>
        <p:spPr>
          <a:xfrm>
            <a:off x="258816" y="231227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6A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5B59A73-9BEB-AC10-E883-A358D1E7C5C9}"/>
              </a:ext>
            </a:extLst>
          </p:cNvPr>
          <p:cNvSpPr txBox="1"/>
          <p:nvPr/>
        </p:nvSpPr>
        <p:spPr>
          <a:xfrm>
            <a:off x="4248536" y="1816133"/>
            <a:ext cx="7393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NF-kB</a:t>
            </a:r>
            <a:endParaRPr kumimoji="1" lang="zh-CN" altLang="en-US" dirty="0"/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71C50937-93D5-932C-3C53-CC04A88504CE}"/>
              </a:ext>
            </a:extLst>
          </p:cNvPr>
          <p:cNvSpPr/>
          <p:nvPr/>
        </p:nvSpPr>
        <p:spPr>
          <a:xfrm>
            <a:off x="2761673" y="2185465"/>
            <a:ext cx="1486863" cy="363771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69522514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08BB02FB-91B9-01D6-A98E-4DF108F8877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1428281">
            <a:off x="404446" y="26844"/>
            <a:ext cx="8480738" cy="6804312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B6FB867C-3BB7-24B6-155D-4D703ACBF260}"/>
              </a:ext>
            </a:extLst>
          </p:cNvPr>
          <p:cNvSpPr txBox="1"/>
          <p:nvPr/>
        </p:nvSpPr>
        <p:spPr>
          <a:xfrm>
            <a:off x="258816" y="231227"/>
            <a:ext cx="1069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Figure</a:t>
            </a:r>
            <a:r>
              <a:rPr kumimoji="1" lang="zh-CN" altLang="en-US" dirty="0"/>
              <a:t> </a:t>
            </a:r>
            <a:r>
              <a:rPr kumimoji="1" lang="en-US" altLang="zh-CN" dirty="0"/>
              <a:t>6A</a:t>
            </a:r>
            <a:endParaRPr kumimoji="1"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E5B59A73-9BEB-AC10-E883-A358D1E7C5C9}"/>
              </a:ext>
            </a:extLst>
          </p:cNvPr>
          <p:cNvSpPr txBox="1"/>
          <p:nvPr/>
        </p:nvSpPr>
        <p:spPr>
          <a:xfrm>
            <a:off x="5061336" y="2444206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/>
              <a:t>B-actin</a:t>
            </a:r>
            <a:endParaRPr kumimoji="1"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7779597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 2013 - 2022">
  <a:themeElements>
    <a:clrScheme name="Office 主题 2013 - 2022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 2013 - 2022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 2013 - 2022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0</TotalTime>
  <Words>39</Words>
  <Application>Microsoft Macintosh PowerPoint</Application>
  <PresentationFormat>全屏显示(4:3)</PresentationFormat>
  <Paragraphs>26</Paragraphs>
  <Slides>1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3</vt:i4>
      </vt:variant>
    </vt:vector>
  </HeadingPairs>
  <TitlesOfParts>
    <vt:vector size="17" baseType="lpstr">
      <vt:lpstr>Arial</vt:lpstr>
      <vt:lpstr>Calibri</vt:lpstr>
      <vt:lpstr>Calibri Light</vt:lpstr>
      <vt:lpstr>Office 主题 2013 - 2022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office user</dc:creator>
  <cp:lastModifiedBy>office user</cp:lastModifiedBy>
  <cp:revision>10</cp:revision>
  <dcterms:created xsi:type="dcterms:W3CDTF">2023-05-06T16:08:38Z</dcterms:created>
  <dcterms:modified xsi:type="dcterms:W3CDTF">2023-05-06T16:59:13Z</dcterms:modified>
</cp:coreProperties>
</file>